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90" d="100"/>
          <a:sy n="90" d="100"/>
        </p:scale>
        <p:origin x="-1254" y="-4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7243B-165B-4A00-918E-998EEEE9F6E7}" type="datetimeFigureOut">
              <a:rPr lang="zh-CN" altLang="en-US" smtClean="0"/>
              <a:t>2015/8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FDF3C-6BB7-4D5F-89C1-8A6D5A027D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6806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7243B-165B-4A00-918E-998EEEE9F6E7}" type="datetimeFigureOut">
              <a:rPr lang="zh-CN" altLang="en-US" smtClean="0"/>
              <a:t>2015/8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FDF3C-6BB7-4D5F-89C1-8A6D5A027D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73727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7243B-165B-4A00-918E-998EEEE9F6E7}" type="datetimeFigureOut">
              <a:rPr lang="zh-CN" altLang="en-US" smtClean="0"/>
              <a:t>2015/8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FDF3C-6BB7-4D5F-89C1-8A6D5A027D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438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7243B-165B-4A00-918E-998EEEE9F6E7}" type="datetimeFigureOut">
              <a:rPr lang="zh-CN" altLang="en-US" smtClean="0"/>
              <a:t>2015/8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FDF3C-6BB7-4D5F-89C1-8A6D5A027D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1751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7243B-165B-4A00-918E-998EEEE9F6E7}" type="datetimeFigureOut">
              <a:rPr lang="zh-CN" altLang="en-US" smtClean="0"/>
              <a:t>2015/8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FDF3C-6BB7-4D5F-89C1-8A6D5A027D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4819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7243B-165B-4A00-918E-998EEEE9F6E7}" type="datetimeFigureOut">
              <a:rPr lang="zh-CN" altLang="en-US" smtClean="0"/>
              <a:t>2015/8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FDF3C-6BB7-4D5F-89C1-8A6D5A027D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9034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7243B-165B-4A00-918E-998EEEE9F6E7}" type="datetimeFigureOut">
              <a:rPr lang="zh-CN" altLang="en-US" smtClean="0"/>
              <a:t>2015/8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FDF3C-6BB7-4D5F-89C1-8A6D5A027D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27076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7243B-165B-4A00-918E-998EEEE9F6E7}" type="datetimeFigureOut">
              <a:rPr lang="zh-CN" altLang="en-US" smtClean="0"/>
              <a:t>2015/8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FDF3C-6BB7-4D5F-89C1-8A6D5A027D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9055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7243B-165B-4A00-918E-998EEEE9F6E7}" type="datetimeFigureOut">
              <a:rPr lang="zh-CN" altLang="en-US" smtClean="0"/>
              <a:t>2015/8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FDF3C-6BB7-4D5F-89C1-8A6D5A027D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31685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7243B-165B-4A00-918E-998EEEE9F6E7}" type="datetimeFigureOut">
              <a:rPr lang="zh-CN" altLang="en-US" smtClean="0"/>
              <a:t>2015/8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FDF3C-6BB7-4D5F-89C1-8A6D5A027D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0048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7243B-165B-4A00-918E-998EEEE9F6E7}" type="datetimeFigureOut">
              <a:rPr lang="zh-CN" altLang="en-US" smtClean="0"/>
              <a:t>2015/8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FDF3C-6BB7-4D5F-89C1-8A6D5A027D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1959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7243B-165B-4A00-918E-998EEEE9F6E7}" type="datetimeFigureOut">
              <a:rPr lang="zh-CN" altLang="en-US" smtClean="0"/>
              <a:t>2015/8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CFDF3C-6BB7-4D5F-89C1-8A6D5A027D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911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415068" y="-727735"/>
            <a:ext cx="11416649" cy="7517763"/>
            <a:chOff x="-2307265" y="-1440116"/>
            <a:chExt cx="11416649" cy="7517763"/>
          </a:xfrm>
        </p:grpSpPr>
        <p:sp>
          <p:nvSpPr>
            <p:cNvPr id="8" name="Right Brace 7"/>
            <p:cNvSpPr/>
            <p:nvPr/>
          </p:nvSpPr>
          <p:spPr>
            <a:xfrm>
              <a:off x="7616800" y="739443"/>
              <a:ext cx="342649" cy="3375654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" name="Right Brace 9"/>
            <p:cNvSpPr/>
            <p:nvPr/>
          </p:nvSpPr>
          <p:spPr>
            <a:xfrm>
              <a:off x="7616800" y="4115097"/>
              <a:ext cx="342649" cy="125692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900399" y="2298421"/>
              <a:ext cx="12089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althy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s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900400" y="4601488"/>
              <a:ext cx="6960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sz="12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AFLD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698444" y="5709003"/>
              <a:ext cx="1189626" cy="3686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tes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7" t="-433" r="3345"/>
            <a:stretch/>
          </p:blipFill>
          <p:spPr>
            <a:xfrm>
              <a:off x="-2307265" y="-1163117"/>
              <a:ext cx="9951640" cy="6913637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623209" y="-1440116"/>
              <a:ext cx="645188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1 Hierarchical clustering of metabolomics data values in NAFLD and healthy control groups.</a:t>
              </a:r>
              <a:endParaRPr lang="fi-FI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056786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</TotalTime>
  <Words>19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ucheng</dc:creator>
  <cp:lastModifiedBy>Cheng Shulin</cp:lastModifiedBy>
  <cp:revision>13</cp:revision>
  <dcterms:created xsi:type="dcterms:W3CDTF">2014-11-28T19:11:35Z</dcterms:created>
  <dcterms:modified xsi:type="dcterms:W3CDTF">2015-08-06T09:47:50Z</dcterms:modified>
</cp:coreProperties>
</file>